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0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D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0" d="100"/>
          <a:sy n="100" d="100"/>
        </p:scale>
        <p:origin x="1836" y="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06/08/2020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60027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6/08/2020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6/08/2020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6/08/2020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6/08/2020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6/08/2020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6/08/2020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6/08/2020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6/08/2020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6/08/2020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6/08/2020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6/08/2020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06/08/2020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.png"/><Relationship Id="rId4" Type="http://schemas.openxmlformats.org/officeDocument/2006/relationships/hyperlink" Target="http://creativecommons.org/licenses/by/4.0/" TargetMode="Externa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251520" y="5674603"/>
            <a:ext cx="799288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en-GB" dirty="0"/>
              <a:t>Grant et al (2020) Diabetologia DOI 10.1007/s00125-020-05248-8 </a:t>
            </a:r>
          </a:p>
          <a:p>
            <a:r>
              <a:rPr lang="en-GB" sz="1200" dirty="0"/>
              <a:t>©The Authors 2020. Distributed under the terms of the CC BY 4.0 Attribution License (</a:t>
            </a:r>
            <a:r>
              <a:rPr lang="en-GB" sz="1200" dirty="0">
                <a:hlinkClick r:id="rId4"/>
              </a:rPr>
              <a:t>http://creativecommons.org/licenses/by/4.0/</a:t>
            </a:r>
            <a:r>
              <a:rPr lang="en-GB" sz="1200" dirty="0"/>
              <a:t>) 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23528" y="260648"/>
            <a:ext cx="87129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Possible promoter interactions in open chromatin regions</a:t>
            </a:r>
            <a:endParaRPr lang="en-GB" sz="2000" b="1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271F1CB4-03E5-4C3D-A49D-62F421A60A0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04638" y="1565273"/>
            <a:ext cx="8150747" cy="33819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5991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43</TotalTime>
  <Words>48</Words>
  <Application>Microsoft Office PowerPoint</Application>
  <PresentationFormat>On-screen Show (4:3)</PresentationFormat>
  <Paragraphs>5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Shelley Williams</cp:lastModifiedBy>
  <cp:revision>39</cp:revision>
  <dcterms:created xsi:type="dcterms:W3CDTF">2016-06-15T12:53:43Z</dcterms:created>
  <dcterms:modified xsi:type="dcterms:W3CDTF">2020-08-06T11:26:40Z</dcterms:modified>
</cp:coreProperties>
</file>